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6" r:id="rId2"/>
    <p:sldId id="258" r:id="rId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EA0F12F-DA2E-49CB-A403-7BE25352FD64}" v="2" dt="2021-02-04T10:25:49.652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5/10/relationships/revisionInfo" Target="revisionInfo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CCAC91F-2804-4C9F-87B8-E2CDC9C1591B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274AE94-0FE9-44A1-97EC-276A8555624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22724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68E07B-96D2-4355-BA3A-A16B8BF08A4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9580FAA-6C6D-4DA7-B727-63408ACDD90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FBF8C1-4CA6-4C0F-948C-7793E3AB35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221A0-333C-4BA3-8E08-CA532023E454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EA2CFC-BC36-425C-B5EC-F02F72A819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757A80-0F4E-4F07-B1D9-28021DB160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2CE75-B032-469F-951C-30B9D326B7A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88462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08C3B0-D30D-44FF-B0E0-6F90CB83CD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335F16B-2789-4055-9F04-7AF90DCC71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F0A03F-C83B-4DF9-800B-F9DA903DD3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221A0-333C-4BA3-8E08-CA532023E454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FD205F-D8CE-4BB3-B215-EE1F36137B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E1A30B-D5F8-4C3A-AE9B-5269C1432D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2CE75-B032-469F-951C-30B9D326B7A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0033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A34FCB1-9CC1-4E20-88E5-534A69F9D42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7BA828F-C530-4ACD-BB78-8056AE7CD9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BA9586-8C27-4BD8-B41D-624C641F27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221A0-333C-4BA3-8E08-CA532023E454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B1AAEE-2D87-47D9-924B-52A26E1C67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E3AAE4-C46B-4F57-AF61-972B16D595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2CE75-B032-469F-951C-30B9D326B7A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25509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88AEC8-4F54-421C-9C88-70BBAA0542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7B524A-94E8-4D18-B096-3D30AAD907F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87977F-9A00-4AD7-88D9-0E0672971C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221A0-333C-4BA3-8E08-CA532023E454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3F0CC4-6FED-4320-BE79-6FD461A579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8D85E7-CD6E-4D8A-9763-6023EA42D9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2CE75-B032-469F-951C-30B9D326B7A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927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9010EA-90BA-471A-BFB5-286D0FFD7B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B3B0CBB-68DC-4F70-8FE4-39383D0BA8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E2F293-41B4-4541-A7C1-3C52610287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221A0-333C-4BA3-8E08-CA532023E454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2C6D6A-684E-4724-BED9-4F7B4BCAB8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2991AE-E1C4-4E0F-9710-CFCC42F0E5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2CE75-B032-469F-951C-30B9D326B7A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10092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B4BA69-D97A-48E2-BEE8-706DACB3CE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03B479E-C813-43D7-B6CF-F4F6934239C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D100D38-46CE-4919-9271-936647D82A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341563A-1A88-437B-ADA0-162B7D5485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221A0-333C-4BA3-8E08-CA532023E454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E4C09B-7541-485A-93F2-5D27974EEF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CD2AB2F-35BA-4703-8148-B2E566511D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2CE75-B032-469F-951C-30B9D326B7A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15272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1E8185-94A4-4883-BA18-08756D08E2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47F5C4-D0B3-44C2-A5D3-65E3BB140C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B8A503B-598F-4427-B3D0-327DAE64659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CF92040-EF55-4F04-A122-7C6FC131A79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B2874F0-5266-4A1A-AB8A-271D2C6093B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56BC503-EDA3-4983-A1E7-C311D45EBF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221A0-333C-4BA3-8E08-CA532023E454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9AD45FB-5F40-4992-94E0-2B43BB5555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A483AF3-EFF9-4256-9464-0DD8D43AF6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2CE75-B032-469F-951C-30B9D326B7A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6223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ABCE63-0A59-4482-AFE8-A15B4FF39B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A880CCD-7538-426F-8775-CC6D0B5C92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221A0-333C-4BA3-8E08-CA532023E454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B82E62F-588C-4150-AB9F-AF32B3D30B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C16149D-CB10-4C56-B235-8B40EFA098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2CE75-B032-469F-951C-30B9D326B7A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49356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5208A4B-1B2A-402D-AAC0-84E52C8C7F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221A0-333C-4BA3-8E08-CA532023E454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B7B9F31-7489-4170-BF9E-A1F1402D69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7467364-5D3E-4018-B787-EE03EDBCB3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2CE75-B032-469F-951C-30B9D326B7A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02887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631BF8-2A77-4D03-9D7B-1207886757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0E9E7A-2206-4860-B41E-36112581832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C0BD1B9-6F12-4736-961C-68B8C98C4C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A872FB4-392B-4A72-9EC4-D6D74996D4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221A0-333C-4BA3-8E08-CA532023E454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831342A-D5D5-4C4D-9694-3724165790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1F93F73-C775-411D-9288-F1DEE726BE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2CE75-B032-469F-951C-30B9D326B7A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41902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60B8C6-944F-4DD9-920C-C5AA033011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AA2E6B6-0EC5-454F-A624-0BF5C33FA5E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C196CE9-9122-4ECA-A6CF-8F48B93842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CE20EEB-C350-45EC-A502-948CE1560B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221A0-333C-4BA3-8E08-CA532023E454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FEE2630-63BD-49F5-94CA-7A4F098A4D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801C342-EA3A-40B8-B922-9E1FC8572F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2CE75-B032-469F-951C-30B9D326B7A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89842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E8AAA5F-8B93-4A98-8E91-3E8435FF4F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2D9678-9DE2-4095-BB36-E011585B5B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9FD429-B5E6-41EB-A626-D5DA2A635BA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9221A0-333C-4BA3-8E08-CA532023E454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09966F-53C2-466C-8CC8-CB4E73B5474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3DEA05-C915-4497-B912-EFF59B111B5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E2CE75-B032-469F-951C-30B9D326B7A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9888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7">
            <a:extLst>
              <a:ext uri="{FF2B5EF4-FFF2-40B4-BE49-F238E27FC236}">
                <a16:creationId xmlns:a16="http://schemas.microsoft.com/office/drawing/2014/main" id="{A158CA15-9561-4064-BAB4-AF3053556A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21091"/>
            <a:ext cx="10515600" cy="494864"/>
          </a:xfrm>
        </p:spPr>
        <p:txBody>
          <a:bodyPr>
            <a:noAutofit/>
          </a:bodyPr>
          <a:lstStyle/>
          <a:p>
            <a:r>
              <a:rPr lang="en-US" sz="3200" dirty="0"/>
              <a:t>Suppl Figure 1</a:t>
            </a:r>
          </a:p>
        </p:txBody>
      </p:sp>
      <p:pic>
        <p:nvPicPr>
          <p:cNvPr id="17" name="Picture 10">
            <a:extLst>
              <a:ext uri="{FF2B5EF4-FFF2-40B4-BE49-F238E27FC236}">
                <a16:creationId xmlns:a16="http://schemas.microsoft.com/office/drawing/2014/main" id="{85A1B295-268F-43A0-A914-268C5D93453F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52356" y="515430"/>
            <a:ext cx="6618782" cy="4784539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TextBox 4">
            <a:extLst>
              <a:ext uri="{FF2B5EF4-FFF2-40B4-BE49-F238E27FC236}">
                <a16:creationId xmlns:a16="http://schemas.microsoft.com/office/drawing/2014/main" id="{12A850D3-0418-4EA4-9367-03FB9CCB86C5}"/>
              </a:ext>
            </a:extLst>
          </p:cNvPr>
          <p:cNvSpPr txBox="1"/>
          <p:nvPr/>
        </p:nvSpPr>
        <p:spPr>
          <a:xfrm>
            <a:off x="562992" y="5433134"/>
            <a:ext cx="1135380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CA on non-sparse components, including all cell types. To define the grouping of cell types, we have used an agnostic, unsupervised method, which consists in performing a Principal Component Analysis, PCA, on the 5 unspecific cell type components. The 11 cell types that were associated with specific NTF components form a separate cluster on the lower left part of the PCA plot.</a:t>
            </a:r>
            <a:endParaRPr lang="fr-FR" sz="18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310049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7">
            <a:extLst>
              <a:ext uri="{FF2B5EF4-FFF2-40B4-BE49-F238E27FC236}">
                <a16:creationId xmlns:a16="http://schemas.microsoft.com/office/drawing/2014/main" id="{A158CA15-9561-4064-BAB4-AF3053556A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05540" y="198119"/>
            <a:ext cx="10515600" cy="494864"/>
          </a:xfrm>
        </p:spPr>
        <p:txBody>
          <a:bodyPr>
            <a:normAutofit fontScale="90000"/>
          </a:bodyPr>
          <a:lstStyle/>
          <a:p>
            <a:r>
              <a:rPr lang="en-US" dirty="0"/>
              <a:t>Suppl Figure 2</a:t>
            </a:r>
          </a:p>
        </p:txBody>
      </p:sp>
      <p:pic>
        <p:nvPicPr>
          <p:cNvPr id="4" name="Picture 32">
            <a:extLst>
              <a:ext uri="{FF2B5EF4-FFF2-40B4-BE49-F238E27FC236}">
                <a16:creationId xmlns:a16="http://schemas.microsoft.com/office/drawing/2014/main" id="{B5820E96-5445-4AA9-BD87-58D38B07E76A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5352" y="1208803"/>
            <a:ext cx="11141029" cy="3534872"/>
          </a:xfrm>
          <a:prstGeom prst="rect">
            <a:avLst/>
          </a:prstGeom>
          <a:noFill/>
        </p:spPr>
      </p:pic>
      <p:sp>
        <p:nvSpPr>
          <p:cNvPr id="5" name="TextBox 5">
            <a:extLst>
              <a:ext uri="{FF2B5EF4-FFF2-40B4-BE49-F238E27FC236}">
                <a16:creationId xmlns:a16="http://schemas.microsoft.com/office/drawing/2014/main" id="{1F9FE1B2-8A44-400D-A0F9-C6CB84596D3C}"/>
              </a:ext>
            </a:extLst>
          </p:cNvPr>
          <p:cNvSpPr txBox="1"/>
          <p:nvPr/>
        </p:nvSpPr>
        <p:spPr>
          <a:xfrm>
            <a:off x="515352" y="4922145"/>
            <a:ext cx="11380725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atterplot of the estimation error versus proportion (study GSE64385). We investigated a possible correlation between the real fraction level and the estimation error. With the exception of B cells, no </a:t>
            </a:r>
            <a:r>
              <a:rPr lang="en-US" sz="18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rrealtion</a:t>
            </a:r>
            <a:r>
              <a:rPr lang="en-US" sz="18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with the estimation error was found for our signatures and the ABIS-seq signature, in contrast to the CIBERSORT signature, which showed a clear negative correlation in 4 of the 5 cell type groups studied – indicating that this signature might be less robust if the real fraction becomes too small.</a:t>
            </a:r>
            <a:endParaRPr lang="fr-FR" sz="18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4569413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</TotalTime>
  <Words>165</Words>
  <Application>Microsoft Office PowerPoint</Application>
  <PresentationFormat>Grand écran</PresentationFormat>
  <Paragraphs>4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Suppl Figure 1</vt:lpstr>
      <vt:lpstr>Suppl Figure 2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 Fogel</dc:creator>
  <cp:lastModifiedBy>Boldina, Galina /FR</cp:lastModifiedBy>
  <cp:revision>19</cp:revision>
  <dcterms:created xsi:type="dcterms:W3CDTF">2020-12-10T13:41:04Z</dcterms:created>
  <dcterms:modified xsi:type="dcterms:W3CDTF">2021-02-04T10:26:56Z</dcterms:modified>
</cp:coreProperties>
</file>